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48" d="100"/>
          <a:sy n="48" d="100"/>
        </p:scale>
        <p:origin x="2100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729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36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115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75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426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502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462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658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198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749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D4047-967F-4AFC-97B0-D989660B0D0B}" type="datetimeFigureOut">
              <a:rPr lang="en-US" smtClean="0"/>
              <a:t>4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50C4A1-F192-4CDD-A72D-073CC4CC3C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242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5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microsoft.com/office/2007/relationships/hdphoto" Target="../media/hdphoto2.wdp"/><Relationship Id="rId7" Type="http://schemas.openxmlformats.org/officeDocument/2006/relationships/image" Target="../media/image10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4.jpeg"/><Relationship Id="rId5" Type="http://schemas.openxmlformats.org/officeDocument/2006/relationships/image" Target="../media/image8.jpeg"/><Relationship Id="rId10" Type="http://schemas.openxmlformats.org/officeDocument/2006/relationships/image" Target="../media/image13.jpg"/><Relationship Id="rId4" Type="http://schemas.openxmlformats.org/officeDocument/2006/relationships/image" Target="../media/image7.jpg"/><Relationship Id="rId9" Type="http://schemas.openxmlformats.org/officeDocument/2006/relationships/image" Target="../media/image12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jpg"/><Relationship Id="rId5" Type="http://schemas.openxmlformats.org/officeDocument/2006/relationships/image" Target="../media/image18.jpg"/><Relationship Id="rId4" Type="http://schemas.openxmlformats.org/officeDocument/2006/relationships/image" Target="../media/image17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jpg"/><Relationship Id="rId4" Type="http://schemas.openxmlformats.org/officeDocument/2006/relationships/image" Target="../media/image2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588" y="3962592"/>
            <a:ext cx="2462949" cy="8384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589" y="623456"/>
            <a:ext cx="2462949" cy="1189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910" t="30683" r="17568" b="39235"/>
          <a:stretch/>
        </p:blipFill>
        <p:spPr>
          <a:xfrm>
            <a:off x="470588" y="2222761"/>
            <a:ext cx="2462949" cy="13843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CasellaDiTesto 8"/>
          <p:cNvSpPr txBox="1"/>
          <p:nvPr/>
        </p:nvSpPr>
        <p:spPr>
          <a:xfrm>
            <a:off x="1067226" y="1790764"/>
            <a:ext cx="19062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thr41-Ser45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2075610" y="3584179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2285508" y="4902457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172269" y="60518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3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0" y="315125"/>
            <a:ext cx="3366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VPA,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m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-   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       2     4     6    24    hour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327676" y="5522251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3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Gruppo 40"/>
          <p:cNvGrpSpPr/>
          <p:nvPr/>
        </p:nvGrpSpPr>
        <p:grpSpPr>
          <a:xfrm>
            <a:off x="221896" y="5660750"/>
            <a:ext cx="4572492" cy="3227699"/>
            <a:chOff x="2285508" y="5700079"/>
            <a:chExt cx="4572492" cy="3227699"/>
          </a:xfrm>
        </p:grpSpPr>
        <p:pic>
          <p:nvPicPr>
            <p:cNvPr id="20" name="Immagine 1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394857" y="6583484"/>
              <a:ext cx="3426693" cy="109476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" name="Immagine 2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285508" y="7908859"/>
              <a:ext cx="3619500" cy="70485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3" name="CasellaDiTesto 22"/>
            <p:cNvSpPr txBox="1"/>
            <p:nvPr/>
          </p:nvSpPr>
          <p:spPr>
            <a:xfrm>
              <a:off x="5755907" y="6012996"/>
              <a:ext cx="110209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VPA, 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mM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orbezomib</a:t>
              </a:r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G132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2894562" y="5970135"/>
              <a:ext cx="15790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3208746" y="5960180"/>
              <a:ext cx="15790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it-IT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3500053" y="5986478"/>
              <a:ext cx="15790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it-IT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3754051" y="6008252"/>
              <a:ext cx="36800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it-IT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it-IT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4157667" y="5986478"/>
              <a:ext cx="15790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4507316" y="5993518"/>
              <a:ext cx="12233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it-IT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4795328" y="6008252"/>
              <a:ext cx="15790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it-IT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5064313" y="6012017"/>
              <a:ext cx="36800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it-IT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it-IT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5420083" y="5993517"/>
              <a:ext cx="12233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it-IT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Connettore diritto 33"/>
            <p:cNvCxnSpPr>
              <a:stCxn id="24" idx="0"/>
            </p:cNvCxnSpPr>
            <p:nvPr/>
          </p:nvCxnSpPr>
          <p:spPr>
            <a:xfrm>
              <a:off x="2973517" y="5970135"/>
              <a:ext cx="173371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CasellaDiTesto 34"/>
            <p:cNvSpPr txBox="1"/>
            <p:nvPr/>
          </p:nvSpPr>
          <p:spPr>
            <a:xfrm>
              <a:off x="3607985" y="573127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Connettore diritto 35"/>
            <p:cNvCxnSpPr/>
            <p:nvPr/>
          </p:nvCxnSpPr>
          <p:spPr>
            <a:xfrm>
              <a:off x="4874282" y="5960180"/>
              <a:ext cx="8527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CasellaDiTesto 37"/>
            <p:cNvSpPr txBox="1"/>
            <p:nvPr/>
          </p:nvSpPr>
          <p:spPr>
            <a:xfrm>
              <a:off x="5106457" y="570007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5064896" y="7619334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it-IT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tenin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5250949" y="8650779"/>
              <a:ext cx="68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it-IT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76111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60724" y="624189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4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4"/>
          <p:cNvSpPr txBox="1"/>
          <p:nvPr/>
        </p:nvSpPr>
        <p:spPr>
          <a:xfrm>
            <a:off x="236071" y="901188"/>
            <a:ext cx="33666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VPA,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m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x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5’DFUR 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1277455" y="863071"/>
            <a:ext cx="1579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1815627" y="901188"/>
            <a:ext cx="1579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it-IT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1519817" y="901188"/>
            <a:ext cx="1579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it-IT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2136944" y="901188"/>
            <a:ext cx="3680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it-IT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Immagine 12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81" t="39042" r="55617" b="27212"/>
          <a:stretch/>
        </p:blipFill>
        <p:spPr>
          <a:xfrm>
            <a:off x="965408" y="2066767"/>
            <a:ext cx="1528176" cy="13188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Immagine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89" t="47998" r="42229" b="18242"/>
          <a:stretch/>
        </p:blipFill>
        <p:spPr>
          <a:xfrm>
            <a:off x="965408" y="3609702"/>
            <a:ext cx="1515650" cy="13193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Immagine 1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895" b="5423"/>
          <a:stretch/>
        </p:blipFill>
        <p:spPr>
          <a:xfrm>
            <a:off x="965408" y="1362853"/>
            <a:ext cx="1515650" cy="5174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CasellaDiTesto 18"/>
          <p:cNvSpPr txBox="1"/>
          <p:nvPr/>
        </p:nvSpPr>
        <p:spPr>
          <a:xfrm>
            <a:off x="1735011" y="1814820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1894581" y="4952020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1138694" y="3327854"/>
            <a:ext cx="1454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Immagine 5"/>
          <p:cNvPicPr>
            <a:picLocks noChangeAspect="1"/>
          </p:cNvPicPr>
          <p:nvPr/>
        </p:nvPicPr>
        <p:blipFill rotWithShape="1">
          <a:blip r:embed="rId6"/>
          <a:srcRect l="5191" b="37280"/>
          <a:stretch/>
        </p:blipFill>
        <p:spPr>
          <a:xfrm>
            <a:off x="4062610" y="1308960"/>
            <a:ext cx="1545858" cy="3938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CasellaDiTesto 4"/>
          <p:cNvSpPr txBox="1"/>
          <p:nvPr/>
        </p:nvSpPr>
        <p:spPr>
          <a:xfrm>
            <a:off x="3291677" y="773210"/>
            <a:ext cx="33666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VPA,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m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x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5’DFUR 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5"/>
          <p:cNvSpPr txBox="1"/>
          <p:nvPr/>
        </p:nvSpPr>
        <p:spPr>
          <a:xfrm>
            <a:off x="4333061" y="735093"/>
            <a:ext cx="1579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sellaDiTesto 6"/>
          <p:cNvSpPr txBox="1"/>
          <p:nvPr/>
        </p:nvSpPr>
        <p:spPr>
          <a:xfrm>
            <a:off x="4871233" y="773210"/>
            <a:ext cx="1579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it-IT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sellaDiTesto 7"/>
          <p:cNvSpPr txBox="1"/>
          <p:nvPr/>
        </p:nvSpPr>
        <p:spPr>
          <a:xfrm>
            <a:off x="4575423" y="773210"/>
            <a:ext cx="1579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it-IT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8"/>
          <p:cNvSpPr txBox="1"/>
          <p:nvPr/>
        </p:nvSpPr>
        <p:spPr>
          <a:xfrm>
            <a:off x="5192550" y="773210"/>
            <a:ext cx="3680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it-IT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0"/>
          <p:cNvSpPr txBox="1"/>
          <p:nvPr/>
        </p:nvSpPr>
        <p:spPr>
          <a:xfrm>
            <a:off x="4144814" y="1715522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t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Immagine 7"/>
          <p:cNvPicPr>
            <a:picLocks noChangeAspect="1"/>
          </p:cNvPicPr>
          <p:nvPr/>
        </p:nvPicPr>
        <p:blipFill rotWithShape="1">
          <a:blip r:embed="rId7"/>
          <a:srcRect l="353" t="6897" r="-353" b="29955"/>
          <a:stretch/>
        </p:blipFill>
        <p:spPr>
          <a:xfrm>
            <a:off x="4043232" y="2886254"/>
            <a:ext cx="1623272" cy="4947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CasellaDiTesto 20"/>
          <p:cNvSpPr txBox="1"/>
          <p:nvPr/>
        </p:nvSpPr>
        <p:spPr>
          <a:xfrm>
            <a:off x="4099268" y="3368778"/>
            <a:ext cx="5697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Immagin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53509" y="3660141"/>
            <a:ext cx="1650252" cy="5455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CasellaDiTesto 20"/>
          <p:cNvSpPr txBox="1"/>
          <p:nvPr/>
        </p:nvSpPr>
        <p:spPr>
          <a:xfrm>
            <a:off x="4070218" y="4263355"/>
            <a:ext cx="7618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DAC-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Picture 33" descr="g3c21_rad 20250401_112719_Ch+Marker.jpg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37" t="42694" r="34003" b="35081"/>
          <a:stretch/>
        </p:blipFill>
        <p:spPr>
          <a:xfrm>
            <a:off x="4095740" y="4502550"/>
            <a:ext cx="1631340" cy="9730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 descr="p53_cmb23 20250403_111514_Ch+Marker.jpg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46" t="52855" r="30502" b="22784"/>
          <a:stretch/>
        </p:blipFill>
        <p:spPr>
          <a:xfrm>
            <a:off x="4057891" y="5854961"/>
            <a:ext cx="1711585" cy="7898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/>
          <p:cNvSpPr txBox="1"/>
          <p:nvPr/>
        </p:nvSpPr>
        <p:spPr>
          <a:xfrm>
            <a:off x="4107377" y="6201310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36" name="CasellaDiTesto 20"/>
          <p:cNvSpPr txBox="1"/>
          <p:nvPr/>
        </p:nvSpPr>
        <p:spPr>
          <a:xfrm>
            <a:off x="4090654" y="5471295"/>
            <a:ext cx="680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asellaDiTesto 20"/>
          <p:cNvSpPr txBox="1"/>
          <p:nvPr/>
        </p:nvSpPr>
        <p:spPr>
          <a:xfrm>
            <a:off x="4107150" y="6708257"/>
            <a:ext cx="595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37" descr="p53_cmb23 20250403_111514_Ch+Marker.jpg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19" t="38578" r="27997" b="33112"/>
          <a:stretch/>
        </p:blipFill>
        <p:spPr>
          <a:xfrm>
            <a:off x="4019725" y="6926994"/>
            <a:ext cx="1725060" cy="8576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CasellaDiTesto 19"/>
          <p:cNvSpPr txBox="1"/>
          <p:nvPr/>
        </p:nvSpPr>
        <p:spPr>
          <a:xfrm>
            <a:off x="4059431" y="7825745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 descr="2. COMBO_08_ATM.jpg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1835" y="1968646"/>
            <a:ext cx="1612614" cy="5101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CasellaDiTesto 20"/>
          <p:cNvSpPr txBox="1"/>
          <p:nvPr/>
        </p:nvSpPr>
        <p:spPr>
          <a:xfrm>
            <a:off x="4115764" y="2461663"/>
            <a:ext cx="471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t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57092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sellaDiTesto 8"/>
          <p:cNvSpPr txBox="1"/>
          <p:nvPr/>
        </p:nvSpPr>
        <p:spPr>
          <a:xfrm>
            <a:off x="293444" y="332289"/>
            <a:ext cx="1056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Fig.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130628" y="693768"/>
            <a:ext cx="3366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VPA,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m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-    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4     6     8    24    hour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2287419" y="2565440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SK3-</a:t>
            </a:r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2287419" y="3821911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Immagine 1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29" t="34161" r="41972" b="41159"/>
          <a:stretch/>
        </p:blipFill>
        <p:spPr>
          <a:xfrm>
            <a:off x="856719" y="1020234"/>
            <a:ext cx="2287314" cy="14112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Immagine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41" t="38328" r="40305" b="45646"/>
          <a:stretch/>
        </p:blipFill>
        <p:spPr>
          <a:xfrm>
            <a:off x="824199" y="2842439"/>
            <a:ext cx="2347665" cy="8151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CasellaDiTesto 14"/>
          <p:cNvSpPr txBox="1"/>
          <p:nvPr/>
        </p:nvSpPr>
        <p:spPr>
          <a:xfrm>
            <a:off x="164117" y="4360022"/>
            <a:ext cx="11678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Fig.8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Immagine 1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8" t="50828" r="46715" b="27056"/>
          <a:stretch/>
        </p:blipFill>
        <p:spPr>
          <a:xfrm>
            <a:off x="1379514" y="5857876"/>
            <a:ext cx="2246894" cy="10335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Immagine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24" t="44739" r="38061" b="44002"/>
          <a:stretch/>
        </p:blipFill>
        <p:spPr>
          <a:xfrm>
            <a:off x="1379514" y="5098000"/>
            <a:ext cx="2246894" cy="5369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Immagine 1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0" t="53097" r="46365" b="26095"/>
          <a:stretch/>
        </p:blipFill>
        <p:spPr>
          <a:xfrm>
            <a:off x="1407345" y="7402142"/>
            <a:ext cx="2246894" cy="97840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CasellaDiTesto 19"/>
          <p:cNvSpPr txBox="1"/>
          <p:nvPr/>
        </p:nvSpPr>
        <p:spPr>
          <a:xfrm>
            <a:off x="2911148" y="6960832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H2AX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3091554" y="8369255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3076257" y="5626258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412908" y="4801332"/>
            <a:ext cx="3366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VPA,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m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-   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  1   2    -  0.5   1    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1908896" y="455529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Connettore diritto 25"/>
          <p:cNvCxnSpPr/>
          <p:nvPr/>
        </p:nvCxnSpPr>
        <p:spPr>
          <a:xfrm>
            <a:off x="1697563" y="4819797"/>
            <a:ext cx="8527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CasellaDiTesto 26"/>
          <p:cNvSpPr txBox="1"/>
          <p:nvPr/>
        </p:nvSpPr>
        <p:spPr>
          <a:xfrm>
            <a:off x="2875502" y="455135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8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Connettore diritto 29"/>
          <p:cNvCxnSpPr/>
          <p:nvPr/>
        </p:nvCxnSpPr>
        <p:spPr>
          <a:xfrm>
            <a:off x="2665180" y="4819797"/>
            <a:ext cx="8527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9512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602527" y="2951658"/>
            <a:ext cx="1176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Fig.9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2"/>
          <a:srcRect t="10792"/>
          <a:stretch/>
        </p:blipFill>
        <p:spPr>
          <a:xfrm>
            <a:off x="602527" y="3845273"/>
            <a:ext cx="4896876" cy="3190004"/>
          </a:xfrm>
          <a:prstGeom prst="rect">
            <a:avLst/>
          </a:prstGeom>
        </p:spPr>
      </p:pic>
      <p:sp>
        <p:nvSpPr>
          <p:cNvPr id="7" name="CasellaDiTesto 6"/>
          <p:cNvSpPr txBox="1"/>
          <p:nvPr/>
        </p:nvSpPr>
        <p:spPr>
          <a:xfrm>
            <a:off x="728810" y="3593326"/>
            <a:ext cx="3366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     2    3   1     2    3     1   2   3      1     2     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855093" y="3257634"/>
            <a:ext cx="3366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VPA   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x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5’DFUR   comb 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277050" y="190791"/>
            <a:ext cx="11506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Fig.9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194" y="823928"/>
            <a:ext cx="3432379" cy="2027669"/>
          </a:xfrm>
          <a:prstGeom prst="rect">
            <a:avLst/>
          </a:prstGeom>
        </p:spPr>
      </p:pic>
      <p:sp>
        <p:nvSpPr>
          <p:cNvPr id="12" name="CasellaDiTesto 11"/>
          <p:cNvSpPr txBox="1"/>
          <p:nvPr/>
        </p:nvSpPr>
        <p:spPr>
          <a:xfrm>
            <a:off x="4953392" y="1138661"/>
            <a:ext cx="832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4953392" y="2327205"/>
            <a:ext cx="6674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1586737" y="564515"/>
            <a:ext cx="3366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     2    3   1     2    3     1   2   3      1     2     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1643475" y="213689"/>
            <a:ext cx="39078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VPA   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x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5’DFUR/  comb</a:t>
            </a:r>
          </a:p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BEVA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 descr="A. gH2ax.jpg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4037" b="-26"/>
          <a:stretch/>
        </p:blipFill>
        <p:spPr>
          <a:xfrm>
            <a:off x="697873" y="7801103"/>
            <a:ext cx="4283765" cy="34635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7" name="Picture 16" descr="E. topi_ACT.jpg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732" b="31270"/>
          <a:stretch/>
        </p:blipFill>
        <p:spPr>
          <a:xfrm>
            <a:off x="689061" y="8889629"/>
            <a:ext cx="4335773" cy="785471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8" name="Picture 17" descr="E. topi_ACT.jpg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431" b="3268"/>
          <a:stretch/>
        </p:blipFill>
        <p:spPr>
          <a:xfrm>
            <a:off x="723634" y="8213424"/>
            <a:ext cx="4265852" cy="610234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9" name="CasellaDiTesto 12"/>
          <p:cNvSpPr txBox="1"/>
          <p:nvPr/>
        </p:nvSpPr>
        <p:spPr>
          <a:xfrm>
            <a:off x="5072801" y="9093226"/>
            <a:ext cx="6674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sellaDiTesto 12"/>
          <p:cNvSpPr txBox="1"/>
          <p:nvPr/>
        </p:nvSpPr>
        <p:spPr>
          <a:xfrm>
            <a:off x="5060246" y="7876722"/>
            <a:ext cx="6674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H2ax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12"/>
          <p:cNvSpPr txBox="1"/>
          <p:nvPr/>
        </p:nvSpPr>
        <p:spPr>
          <a:xfrm>
            <a:off x="5080682" y="8391965"/>
            <a:ext cx="1517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3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sellaDiTesto 3"/>
          <p:cNvSpPr txBox="1"/>
          <p:nvPr/>
        </p:nvSpPr>
        <p:spPr>
          <a:xfrm>
            <a:off x="4961277" y="9629001"/>
            <a:ext cx="12533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Fig.10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sellaDiTesto 6"/>
          <p:cNvSpPr txBox="1"/>
          <p:nvPr/>
        </p:nvSpPr>
        <p:spPr>
          <a:xfrm>
            <a:off x="1260607" y="7473104"/>
            <a:ext cx="4925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          2      1     2       1         2       1      2         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7"/>
          <p:cNvSpPr txBox="1"/>
          <p:nvPr/>
        </p:nvSpPr>
        <p:spPr>
          <a:xfrm>
            <a:off x="1386890" y="7137412"/>
            <a:ext cx="3366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VPA   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x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5’DFUR   comb 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471312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2</TotalTime>
  <Words>194</Words>
  <Application>Microsoft Office PowerPoint</Application>
  <PresentationFormat>A4 (21x29,7 cm)</PresentationFormat>
  <Paragraphs>97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erena Roca</dc:creator>
  <cp:lastModifiedBy>utente</cp:lastModifiedBy>
  <cp:revision>12</cp:revision>
  <dcterms:created xsi:type="dcterms:W3CDTF">2025-01-15T07:18:11Z</dcterms:created>
  <dcterms:modified xsi:type="dcterms:W3CDTF">2025-04-27T15:01:18Z</dcterms:modified>
</cp:coreProperties>
</file>